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wmf" ContentType="image/x-wmf"/>
  <Override PartName="/ppt/media/image4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12193588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85B1D5A-2DD7-4C25-8F33-07AE4341C62E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09480" y="3968280"/>
            <a:ext cx="109713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636F902-7177-4D90-AD9D-CB0BE61F3E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09480" y="39682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31600" y="39682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47EE359-3476-4305-9A66-30452E3365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19280" y="16048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028720" y="16048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09480" y="39682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19280" y="39682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028720" y="39682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22F752B-9683-486F-A697-83D26F936B00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21F27369-0AA3-4CAF-BE1D-703CAAE2B2C9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609480" y="1604880"/>
            <a:ext cx="109713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0080717A-9281-4B4B-AFB2-A359669BCA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C008887A-5B50-47F9-ABE7-4E447CD616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3BAD952A-06E7-4BF4-93A3-96AA3B103A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DBA7540-F8A2-4D8A-8433-3413AAF8E8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09480" y="272520"/>
            <a:ext cx="109713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38EB84F7-28D4-432B-988D-B623FF967A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609480" y="39682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3062DE08-1D9A-4F92-99D2-74A71BF705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480" y="1604880"/>
            <a:ext cx="109713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DE2CA4D-AF00-49BE-9250-EAD1336B59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6231600" y="39682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8665ABEE-C133-456D-AD3D-C17F6518E6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609480" y="3968280"/>
            <a:ext cx="109713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B1C1D53C-D56B-4C7B-98CF-C49A824566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609480" y="3968280"/>
            <a:ext cx="109713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E0CE3E15-8944-401F-9BF1-8CD71FF013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609480" y="39682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6231600" y="39682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C0804318-9A5A-4338-BCB4-FA3B6E4212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19280" y="16048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8028720" y="16048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609480" y="39682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4319280" y="39682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8028720" y="3968280"/>
            <a:ext cx="35326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EBCDC92-B1C5-4827-8C36-30E74E94AFEF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3F951B7-7C1F-4040-A51C-1ADCC68F92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DA7B4DC-F3DD-477E-98F1-D93331B2EA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6B7A4F8-C743-42EA-956C-06407DA621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09480" y="272520"/>
            <a:ext cx="109713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F5B0BE5-1217-42B8-9EB7-4964902D01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09480" y="39682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AF53A46-635A-4FF5-9129-8A20571E09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31600" y="39682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C933AE1-B5BB-4F94-ACD8-F3BD77C22C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09480" y="3968280"/>
            <a:ext cx="109713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CA10D95-567E-42F3-93FD-AF6250D2B1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8380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8/7/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86104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FBE52A91-3086-46CD-AE4A-80F0170CEEC0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609480" y="1604880"/>
            <a:ext cx="109713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3"/>
          </p:nvPr>
        </p:nvSpPr>
        <p:spPr>
          <a:xfrm>
            <a:off x="8380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8/7/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sldNum" idx="4"/>
          </p:nvPr>
        </p:nvSpPr>
        <p:spPr>
          <a:xfrm>
            <a:off x="86104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28AAAB94-9AF1-4B0D-AB6E-C6C6E0B7DBB5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1526760" y="520560"/>
            <a:ext cx="89636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 Venn Diagram of overlap in genes and non-coding RNA for three racial/ethnic grou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" descr=""/>
          <p:cNvPicPr/>
          <p:nvPr/>
        </p:nvPicPr>
        <p:blipFill>
          <a:blip r:embed="rId1"/>
          <a:srcRect l="0" t="31660" r="17630" b="10658"/>
          <a:stretch/>
        </p:blipFill>
        <p:spPr>
          <a:xfrm>
            <a:off x="3124080" y="2228760"/>
            <a:ext cx="5019840" cy="4143600"/>
          </a:xfrm>
          <a:prstGeom prst="rect">
            <a:avLst/>
          </a:prstGeom>
          <a:ln w="0">
            <a:noFill/>
          </a:ln>
        </p:spPr>
      </p:pic>
      <p:sp>
        <p:nvSpPr>
          <p:cNvPr id="84" name=""/>
          <p:cNvSpPr/>
          <p:nvPr/>
        </p:nvSpPr>
        <p:spPr>
          <a:xfrm>
            <a:off x="4423320" y="6267600"/>
            <a:ext cx="2017080" cy="39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Native Hawaiian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760480" y="2209680"/>
            <a:ext cx="929160" cy="39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Whit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6989400" y="2209680"/>
            <a:ext cx="1146960" cy="39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Japanes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"/>
          <p:cNvSpPr/>
          <p:nvPr/>
        </p:nvSpPr>
        <p:spPr>
          <a:xfrm>
            <a:off x="439560" y="128520"/>
            <a:ext cx="67359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2 Regulatory features of cg13986536 in 9q34.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" descr=""/>
          <p:cNvPicPr/>
          <p:nvPr/>
        </p:nvPicPr>
        <p:blipFill>
          <a:blip r:embed="rId1"/>
          <a:srcRect l="0" t="5017" r="0" b="0"/>
          <a:stretch/>
        </p:blipFill>
        <p:spPr>
          <a:xfrm>
            <a:off x="0" y="619200"/>
            <a:ext cx="12192120" cy="5932440"/>
          </a:xfrm>
          <a:prstGeom prst="rect">
            <a:avLst/>
          </a:prstGeom>
          <a:ln w="0">
            <a:noFill/>
          </a:ln>
        </p:spPr>
      </p:pic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"/>
          <p:cNvSpPr/>
          <p:nvPr/>
        </p:nvSpPr>
        <p:spPr>
          <a:xfrm>
            <a:off x="838080" y="1825560"/>
            <a:ext cx="10515600" cy="435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" name="" descr=""/>
          <p:cNvPicPr/>
          <p:nvPr/>
        </p:nvPicPr>
        <p:blipFill>
          <a:blip r:embed="rId1"/>
          <a:srcRect l="0" t="0" r="754" b="0"/>
          <a:stretch/>
        </p:blipFill>
        <p:spPr>
          <a:xfrm>
            <a:off x="684360" y="608040"/>
            <a:ext cx="10740960" cy="6180120"/>
          </a:xfrm>
          <a:prstGeom prst="rect">
            <a:avLst/>
          </a:prstGeom>
          <a:ln w="0">
            <a:noFill/>
          </a:ln>
        </p:spPr>
      </p:pic>
      <p:sp>
        <p:nvSpPr>
          <p:cNvPr id="91" name=""/>
          <p:cNvSpPr/>
          <p:nvPr/>
        </p:nvSpPr>
        <p:spPr>
          <a:xfrm>
            <a:off x="439560" y="128520"/>
            <a:ext cx="70628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3 Regulatory features of cg21842914 in 17q25.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"/>
          <p:cNvSpPr/>
          <p:nvPr/>
        </p:nvSpPr>
        <p:spPr>
          <a:xfrm>
            <a:off x="439560" y="128520"/>
            <a:ext cx="68756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4 Regulatory features of cg11413570 in 1p13.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" descr=""/>
          <p:cNvPicPr/>
          <p:nvPr/>
        </p:nvPicPr>
        <p:blipFill>
          <a:blip r:embed="rId1"/>
          <a:srcRect l="0" t="5076" r="0" b="0"/>
          <a:stretch/>
        </p:blipFill>
        <p:spPr>
          <a:xfrm>
            <a:off x="0" y="950760"/>
            <a:ext cx="12192120" cy="5234040"/>
          </a:xfrm>
          <a:prstGeom prst="rect">
            <a:avLst/>
          </a:prstGeom>
          <a:ln w="0">
            <a:noFill/>
          </a:ln>
        </p:spPr>
      </p:pic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"/>
          <p:cNvSpPr/>
          <p:nvPr/>
        </p:nvSpPr>
        <p:spPr>
          <a:xfrm>
            <a:off x="1095120" y="289080"/>
            <a:ext cx="526032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5 Regulatory features of cg00812246 in 1p32.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" descr=""/>
          <p:cNvPicPr/>
          <p:nvPr/>
        </p:nvPicPr>
        <p:blipFill>
          <a:blip r:embed="rId1"/>
          <a:srcRect l="0" t="4167" r="0" b="0"/>
          <a:stretch/>
        </p:blipFill>
        <p:spPr>
          <a:xfrm>
            <a:off x="0" y="1108080"/>
            <a:ext cx="12192120" cy="5749920"/>
          </a:xfrm>
          <a:prstGeom prst="rect">
            <a:avLst/>
          </a:prstGeom>
          <a:ln w="0">
            <a:noFill/>
          </a:ln>
        </p:spPr>
      </p:pic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"/>
          <p:cNvSpPr/>
          <p:nvPr/>
        </p:nvSpPr>
        <p:spPr>
          <a:xfrm>
            <a:off x="1109160" y="128520"/>
            <a:ext cx="526032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6 Regulatory features of cg09168939 in 1q23.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" descr=""/>
          <p:cNvPicPr/>
          <p:nvPr/>
        </p:nvPicPr>
        <p:blipFill>
          <a:blip r:embed="rId1"/>
          <a:srcRect l="0" t="5277" r="0" b="0"/>
          <a:stretch/>
        </p:blipFill>
        <p:spPr>
          <a:xfrm>
            <a:off x="0" y="739800"/>
            <a:ext cx="12192120" cy="5697360"/>
          </a:xfrm>
          <a:prstGeom prst="rect">
            <a:avLst/>
          </a:prstGeom>
          <a:ln w="0">
            <a:noFill/>
          </a:ln>
        </p:spPr>
      </p:pic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"/>
          <p:cNvSpPr/>
          <p:nvPr/>
        </p:nvSpPr>
        <p:spPr>
          <a:xfrm>
            <a:off x="1109160" y="128520"/>
            <a:ext cx="526032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7 Regulatory features of cg11108534 in 2p25.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" descr=""/>
          <p:cNvPicPr/>
          <p:nvPr/>
        </p:nvPicPr>
        <p:blipFill>
          <a:blip r:embed="rId1"/>
          <a:srcRect l="0" t="4370" r="0" b="0"/>
          <a:stretch/>
        </p:blipFill>
        <p:spPr>
          <a:xfrm>
            <a:off x="0" y="914400"/>
            <a:ext cx="12192120" cy="526896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